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6076" autoAdjust="0"/>
  </p:normalViewPr>
  <p:slideViewPr>
    <p:cSldViewPr snapToGrid="0">
      <p:cViewPr varScale="1">
        <p:scale>
          <a:sx n="62" d="100"/>
          <a:sy n="62" d="100"/>
        </p:scale>
        <p:origin x="26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877BA4C9-CB5E-5A19-CCE4-85DA130AD6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4622" y="2173409"/>
            <a:ext cx="4948756" cy="374161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D881A31-A64C-4CAF-85A4-4ED71B745A92}"/>
              </a:ext>
            </a:extLst>
          </p:cNvPr>
          <p:cNvSpPr/>
          <p:nvPr/>
        </p:nvSpPr>
        <p:spPr>
          <a:xfrm>
            <a:off x="288275" y="6373123"/>
            <a:ext cx="6408813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: Figure S1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rmination curves of primary dormant tomato seeds during two successive 5d imbibition periods at 20°C in the dark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represent the germination percentage ± standard </a:t>
            </a:r>
            <a:r>
              <a:rPr lang="en-GB" sz="110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ror of three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licates of 60 seeds (only two for genotype H10-165). T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 rolled-up arrow corresponds to the replacement of the exudate by fresh water.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, imbibition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5135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78</TotalTime>
  <Words>67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08</cp:revision>
  <dcterms:created xsi:type="dcterms:W3CDTF">2023-08-10T14:53:51Z</dcterms:created>
  <dcterms:modified xsi:type="dcterms:W3CDTF">2024-01-17T14:50:31Z</dcterms:modified>
</cp:coreProperties>
</file>